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599988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39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46" d="100"/>
          <a:sy n="46" d="100"/>
        </p:scale>
        <p:origin x="2035" y="43"/>
      </p:cViewPr>
      <p:guideLst>
        <p:guide orient="horz" pos="3969"/>
        <p:guide pos="39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062083"/>
            <a:ext cx="10709990" cy="438666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6617911"/>
            <a:ext cx="9449991" cy="3042080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38943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7723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670833"/>
            <a:ext cx="2716872" cy="1067790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670833"/>
            <a:ext cx="7993117" cy="1067790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04566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90776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141251"/>
            <a:ext cx="10867490" cy="5241244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8432079"/>
            <a:ext cx="10867490" cy="275624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97859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354163"/>
            <a:ext cx="5354995" cy="7994577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354163"/>
            <a:ext cx="5354995" cy="7994577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07538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70836"/>
            <a:ext cx="10867490" cy="2435415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088748"/>
            <a:ext cx="5330385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602496"/>
            <a:ext cx="5330385" cy="676957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088748"/>
            <a:ext cx="5356636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602496"/>
            <a:ext cx="5356636" cy="676957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332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97711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55611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814168"/>
            <a:ext cx="6378744" cy="8954158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43806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814168"/>
            <a:ext cx="6378744" cy="8954158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79911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670836"/>
            <a:ext cx="1086749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354163"/>
            <a:ext cx="1086749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3212F-3366-4533-9ED6-002216DD793C}" type="datetimeFigureOut">
              <a:rPr lang="pt-BR" smtClean="0"/>
              <a:t>15/09/2022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1678325"/>
            <a:ext cx="42524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55AB4-1E71-40F5-8962-DBDE5C889F6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95741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m 8" descr="Uma imagem contendo Padrão do plano de fundo&#10;&#10;Descrição gerada automaticamente">
            <a:extLst>
              <a:ext uri="{FF2B5EF4-FFF2-40B4-BE49-F238E27FC236}">
                <a16:creationId xmlns:a16="http://schemas.microsoft.com/office/drawing/2014/main" id="{98D81C33-D3ED-4A69-8905-E08D9159EF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038" y="680244"/>
            <a:ext cx="5475257" cy="4381500"/>
          </a:xfrm>
          <a:prstGeom prst="rect">
            <a:avLst/>
          </a:prstGeom>
        </p:spPr>
      </p:pic>
      <p:pic>
        <p:nvPicPr>
          <p:cNvPr id="15" name="Imagem 14" descr="Imagem em branco e preto&#10;&#10;Descrição gerada automaticamente com confiança baixa">
            <a:extLst>
              <a:ext uri="{FF2B5EF4-FFF2-40B4-BE49-F238E27FC236}">
                <a16:creationId xmlns:a16="http://schemas.microsoft.com/office/drawing/2014/main" id="{B8A2D241-1EAB-46DE-8ED2-A90BC447B3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0081" y="5347494"/>
            <a:ext cx="5475257" cy="4381500"/>
          </a:xfrm>
          <a:prstGeom prst="rect">
            <a:avLst/>
          </a:prstGeom>
        </p:spPr>
      </p:pic>
      <p:pic>
        <p:nvPicPr>
          <p:cNvPr id="17" name="Imagem 16" descr="Montanha com neve&#10;&#10;Descrição gerada automaticamente com confiança média">
            <a:extLst>
              <a:ext uri="{FF2B5EF4-FFF2-40B4-BE49-F238E27FC236}">
                <a16:creationId xmlns:a16="http://schemas.microsoft.com/office/drawing/2014/main" id="{824C8CC2-047C-4E92-B66D-6CDC465709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738" y="5347494"/>
            <a:ext cx="5475257" cy="4381500"/>
          </a:xfrm>
          <a:prstGeom prst="rect">
            <a:avLst/>
          </a:prstGeom>
        </p:spPr>
      </p:pic>
      <p:pic>
        <p:nvPicPr>
          <p:cNvPr id="19" name="Imagem 18" descr="Tecido com texto preto sobre fundo azul&#10;&#10;Descrição gerada automaticamente com confiança baixa">
            <a:extLst>
              <a:ext uri="{FF2B5EF4-FFF2-40B4-BE49-F238E27FC236}">
                <a16:creationId xmlns:a16="http://schemas.microsoft.com/office/drawing/2014/main" id="{4E4293A8-D81E-4374-8405-97BCA5D665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0081" y="680244"/>
            <a:ext cx="5475258" cy="4381501"/>
          </a:xfrm>
          <a:prstGeom prst="rect">
            <a:avLst/>
          </a:prstGeom>
        </p:spPr>
      </p:pic>
      <p:sp>
        <p:nvSpPr>
          <p:cNvPr id="20" name="CaixaDeTexto 19">
            <a:extLst>
              <a:ext uri="{FF2B5EF4-FFF2-40B4-BE49-F238E27FC236}">
                <a16:creationId xmlns:a16="http://schemas.microsoft.com/office/drawing/2014/main" id="{DF9EFC43-A455-4793-A613-29B904E8238C}"/>
              </a:ext>
            </a:extLst>
          </p:cNvPr>
          <p:cNvSpPr txBox="1"/>
          <p:nvPr/>
        </p:nvSpPr>
        <p:spPr>
          <a:xfrm>
            <a:off x="834190" y="680244"/>
            <a:ext cx="3561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/>
              <a:t>A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394E2726-E900-4D80-A6E9-01A4EF49B0FC}"/>
              </a:ext>
            </a:extLst>
          </p:cNvPr>
          <p:cNvSpPr txBox="1"/>
          <p:nvPr/>
        </p:nvSpPr>
        <p:spPr>
          <a:xfrm>
            <a:off x="6505077" y="680244"/>
            <a:ext cx="3561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099FF40E-6BDD-4910-95F4-52FA12F67E09}"/>
              </a:ext>
            </a:extLst>
          </p:cNvPr>
          <p:cNvSpPr txBox="1"/>
          <p:nvPr/>
        </p:nvSpPr>
        <p:spPr>
          <a:xfrm>
            <a:off x="826170" y="5356511"/>
            <a:ext cx="3337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/>
              <a:t>C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D1A7E793-0D9D-4007-82BD-D025A50D3CD5}"/>
              </a:ext>
            </a:extLst>
          </p:cNvPr>
          <p:cNvSpPr txBox="1"/>
          <p:nvPr/>
        </p:nvSpPr>
        <p:spPr>
          <a:xfrm>
            <a:off x="6497057" y="5356511"/>
            <a:ext cx="3626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/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1F6D9B1-BDDF-B0B6-FD5A-B0037CD97BA2}"/>
              </a:ext>
            </a:extLst>
          </p:cNvPr>
          <p:cNvSpPr txBox="1"/>
          <p:nvPr/>
        </p:nvSpPr>
        <p:spPr>
          <a:xfrm>
            <a:off x="834190" y="10580914"/>
            <a:ext cx="1134692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Figure </a:t>
            </a:r>
            <a:r>
              <a:rPr lang="en-GB" b="1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S</a:t>
            </a:r>
            <a:r>
              <a:rPr lang="pl-PL" b="1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1. </a:t>
            </a:r>
            <a:r>
              <a:rPr lang="pl-PL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A &amp; B . Epstein-Barr virus–encoded RNA (EBER) automated in-situ hybridization (ISH), representative results, A: negative (x4 magnification, scale bar 200 </a:t>
            </a:r>
            <a:r>
              <a:rPr lang="el-GR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pl-PL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m), B: positive (x20 magnification, scale bar 50 </a:t>
            </a:r>
            <a:r>
              <a:rPr lang="el-GR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pl-PL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m). C &amp; D. The proportion of PD-L1–expressing tumor cells, representative immunohistochemistry (IHC) results, C: negative (x40 magnification, scale bar 200 </a:t>
            </a:r>
            <a:r>
              <a:rPr lang="el-GR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pl-PL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m), D: positive (x20 magnification, scale bar 50 </a:t>
            </a:r>
            <a:r>
              <a:rPr lang="el-GR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pl-PL" b="0" i="0" dirty="0">
                <a:solidFill>
                  <a:srgbClr val="2E3924"/>
                </a:solidFill>
                <a:effectLst/>
                <a:latin typeface="Arial" panose="020B0604020202020204" pitchFamily="34" charset="0"/>
              </a:rPr>
              <a:t>m).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773559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01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idia Rebolho Arantes</dc:creator>
  <cp:lastModifiedBy>MDPI-76</cp:lastModifiedBy>
  <cp:revision>3</cp:revision>
  <dcterms:created xsi:type="dcterms:W3CDTF">2022-09-12T12:14:25Z</dcterms:created>
  <dcterms:modified xsi:type="dcterms:W3CDTF">2022-09-15T12:35:28Z</dcterms:modified>
</cp:coreProperties>
</file>